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1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1662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ioka Ryohei" userId="7e8b618b15cf52c5" providerId="LiveId" clId="{7FA285D2-D77F-4925-8269-27ADF44112E9}"/>
    <pc:docChg chg="modSld">
      <pc:chgData name="Norioka Ryohei" userId="7e8b618b15cf52c5" providerId="LiveId" clId="{7FA285D2-D77F-4925-8269-27ADF44112E9}" dt="2021-02-24T06:24:10.070" v="3" actId="20577"/>
      <pc:docMkLst>
        <pc:docMk/>
      </pc:docMkLst>
      <pc:sldChg chg="modSp mod">
        <pc:chgData name="Norioka Ryohei" userId="7e8b618b15cf52c5" providerId="LiveId" clId="{7FA285D2-D77F-4925-8269-27ADF44112E9}" dt="2021-02-24T06:24:10.070" v="3" actId="20577"/>
        <pc:sldMkLst>
          <pc:docMk/>
          <pc:sldMk cId="1567232843" sldId="256"/>
        </pc:sldMkLst>
        <pc:spChg chg="mod">
          <ac:chgData name="Norioka Ryohei" userId="7e8b618b15cf52c5" providerId="LiveId" clId="{7FA285D2-D77F-4925-8269-27ADF44112E9}" dt="2021-02-24T06:24:10.070" v="3" actId="20577"/>
          <ac:spMkLst>
            <pc:docMk/>
            <pc:sldMk cId="1567232843" sldId="256"/>
            <ac:spMk id="4" creationId="{B0801BFD-E392-4EE6-99AA-B1E1E4806B8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285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65159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994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6148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3574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7547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6136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431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92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904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1254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B4130D-CE4D-4955-A381-4F3239B0E237}" type="datetimeFigureOut">
              <a:rPr kumimoji="1" lang="ja-JP" altLang="en-US" smtClean="0"/>
              <a:t>2021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320B80-1A9F-447D-9A3C-CA0D867A15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261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8E1C50E-AB6A-4798-BFCF-EE36AE896CD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825" y="526635"/>
            <a:ext cx="6400417" cy="4107558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0801BFD-E392-4EE6-99AA-B1E1E4806B86}"/>
              </a:ext>
            </a:extLst>
          </p:cNvPr>
          <p:cNvSpPr txBox="1"/>
          <p:nvPr/>
        </p:nvSpPr>
        <p:spPr>
          <a:xfrm>
            <a:off x="803435" y="4774747"/>
            <a:ext cx="5459506" cy="4866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ja-JP" altLang="ja-JP" sz="1200" b="1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. 1. 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/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idbrain atrophy related to parkinsonism in a non-coding </a:t>
            </a:r>
            <a:r>
              <a:rPr lang="en-US" altLang="ja-JP" sz="10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peat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expansion disorder: five cases of spinocerebellar ataxia type 31 with nigrostriatal dopaminergic dysfunction</a:t>
            </a:r>
            <a:endParaRPr lang="ja-JP" altLang="ja-JP" sz="105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/>
            <a:r>
              <a:rPr lang="en-US" altLang="ja-JP" sz="10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erebellum</a:t>
            </a:r>
            <a:r>
              <a:rPr lang="ja-JP" altLang="en-US" sz="10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amp;</a:t>
            </a:r>
            <a:r>
              <a:rPr lang="ja-JP" altLang="en-US" sz="10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taxias</a:t>
            </a:r>
            <a:endParaRPr lang="ja-JP" altLang="ja-JP" sz="105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/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yohei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orioka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zo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gaya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ki Murayama,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moya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Kawazoe,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hinsuke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isawa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kihiro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awata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azushi Takahashi</a:t>
            </a:r>
            <a:endParaRPr lang="ja-JP" altLang="ja-JP" sz="105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/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Neurology, Tokyo Metropolitan Neurological Hospital</a:t>
            </a:r>
            <a:endParaRPr lang="ja-JP" altLang="ja-JP" sz="105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/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mail: Keizo_Sugaya@member.metro.tokyo.jp</a:t>
            </a:r>
            <a:endParaRPr lang="ja-JP" altLang="ja-JP" sz="105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ja-JP" altLang="ja-JP" sz="1200" b="1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Linear regression analysis comparing disease duration and 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pographical</a:t>
            </a:r>
            <a:r>
              <a:rPr lang="ja-JP" altLang="ja-JP" sz="1200" b="1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atrophy on midline sagittal images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Closed triangle: linear relationship between disease duration at MRI acquisition and C/P area ratio (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oefficient of determination,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R</a:t>
            </a:r>
            <a:r>
              <a:rPr lang="en-US" altLang="ja-JP" sz="12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2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= 0.305,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= 0.014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). Closed circle: linear relationship between disease duration at MRI acquisition and M/P area ratio (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R</a:t>
            </a:r>
            <a:r>
              <a:rPr lang="en-US" altLang="ja-JP" sz="12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2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= 0.157,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= 0.093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). Black arrow shows each patient in the NSDD(+) group. C/P, cerebellum-to-pons; M/P, midbrain-to-pons; NSDD,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igrostriatal dopaminergic dysfunction; </a:t>
            </a:r>
            <a:r>
              <a:rPr lang="ja-JP" altLang="ja-JP" sz="1200" kern="100" dirty="0">
                <a:effectLst/>
                <a:latin typeface="游明朝" panose="02020400000000000000" pitchFamily="18" charset="-128"/>
                <a:ea typeface="Times New Roman" panose="02020603050405020304" pitchFamily="18" charset="0"/>
                <a:cs typeface="Times New Roman" panose="02020603050405020304" pitchFamily="18" charset="0"/>
              </a:rPr>
              <a:t>NSDD(+), SCA31 with NSDD; SCA31, spinocerebellar ataxia type 31 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7232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97</Words>
  <Application>Microsoft Office PowerPoint</Application>
  <PresentationFormat>A4 210 x 297 mm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菅谷 慶三</dc:creator>
  <cp:lastModifiedBy>菅谷 慶三</cp:lastModifiedBy>
  <cp:revision>6</cp:revision>
  <cp:lastPrinted>2020-10-29T21:36:46Z</cp:lastPrinted>
  <dcterms:created xsi:type="dcterms:W3CDTF">2020-10-24T09:21:11Z</dcterms:created>
  <dcterms:modified xsi:type="dcterms:W3CDTF">2021-02-26T17:52:56Z</dcterms:modified>
</cp:coreProperties>
</file>